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notesMasterIdLst>
    <p:notesMasterId r:id="rId3"/>
  </p:notesMasterIdLst>
  <p:sldIdLst>
    <p:sldId id="36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8CDF"/>
    <a:srgbClr val="16A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749" autoAdjust="0"/>
    <p:restoredTop sz="88454" autoAdjust="0"/>
  </p:normalViewPr>
  <p:slideViewPr>
    <p:cSldViewPr>
      <p:cViewPr varScale="1">
        <p:scale>
          <a:sx n="85" d="100"/>
          <a:sy n="85" d="100"/>
        </p:scale>
        <p:origin x="2886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2FAFD0-EF8C-554B-B034-4442DE591FA0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B1FB10-D472-764B-87F9-C134BDEA3E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183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1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4337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8408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8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8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48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8122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0949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7935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5369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1372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46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7" y="36408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8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1396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8140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1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4334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4CCBAA45-BC5F-3CBE-57FB-251DFC54A941}"/>
              </a:ext>
            </a:extLst>
          </p:cNvPr>
          <p:cNvGrpSpPr/>
          <p:nvPr/>
        </p:nvGrpSpPr>
        <p:grpSpPr>
          <a:xfrm>
            <a:off x="885128" y="381000"/>
            <a:ext cx="5363272" cy="3892114"/>
            <a:chOff x="838200" y="2117739"/>
            <a:chExt cx="4435426" cy="3287838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FDA4A5EF-DCE1-322D-ED30-DC7A5BB28BA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81032968"/>
                </p:ext>
              </p:extLst>
            </p:nvPr>
          </p:nvGraphicFramePr>
          <p:xfrm>
            <a:off x="960809" y="2117739"/>
            <a:ext cx="3671401" cy="27988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3312888" imgH="2526481" progId="Prism10.Document">
                    <p:embed/>
                  </p:oleObj>
                </mc:Choice>
                <mc:Fallback>
                  <p:oleObj name="Prism 10" r:id="rId2" imgW="3312888" imgH="2526481" progId="Prism10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FDA4A5EF-DCE1-322D-ED30-DC7A5BB28BA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960809" y="2117739"/>
                          <a:ext cx="3671401" cy="27988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7" name="TextBox 126"/>
            <p:cNvSpPr txBox="1"/>
            <p:nvPr/>
          </p:nvSpPr>
          <p:spPr>
            <a:xfrm>
              <a:off x="847325" y="2210056"/>
              <a:ext cx="317311" cy="2079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304CCBBF-1FB7-A902-736E-BABD76AD9AF9}"/>
                </a:ext>
              </a:extLst>
            </p:cNvPr>
            <p:cNvGrpSpPr/>
            <p:nvPr/>
          </p:nvGrpSpPr>
          <p:grpSpPr>
            <a:xfrm>
              <a:off x="838200" y="2800448"/>
              <a:ext cx="4435426" cy="2605129"/>
              <a:chOff x="668663" y="2699186"/>
              <a:chExt cx="4435426" cy="2605129"/>
            </a:xfrm>
          </p:grpSpPr>
          <p:sp>
            <p:nvSpPr>
              <p:cNvPr id="63" name="TextBox 62"/>
              <p:cNvSpPr txBox="1"/>
              <p:nvPr/>
            </p:nvSpPr>
            <p:spPr>
              <a:xfrm>
                <a:off x="3663968" y="4648200"/>
                <a:ext cx="6832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458-8</a:t>
                </a: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2700976" y="4648200"/>
                <a:ext cx="6832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458-2</a:t>
                </a: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1861464" y="4648200"/>
                <a:ext cx="63773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458</a:t>
                </a: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831215" y="2867580"/>
                <a:ext cx="4191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915353" y="3547749"/>
                <a:ext cx="33496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915353" y="4254626"/>
                <a:ext cx="39116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3515771" y="4394538"/>
                <a:ext cx="4339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2615622" y="4394538"/>
                <a:ext cx="41013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1740826" y="4394538"/>
                <a:ext cx="533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3101653" y="4394538"/>
                <a:ext cx="34185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2208012" y="4394538"/>
                <a:ext cx="34711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3998712" y="4394538"/>
                <a:ext cx="30901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1183529" y="4648200"/>
                <a:ext cx="63773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</a:t>
                </a:r>
              </a:p>
            </p:txBody>
          </p:sp>
          <p:cxnSp>
            <p:nvCxnSpPr>
              <p:cNvPr id="7" name="Straight Connector 6"/>
              <p:cNvCxnSpPr>
                <a:cxnSpLocks/>
              </p:cNvCxnSpPr>
              <p:nvPr/>
            </p:nvCxnSpPr>
            <p:spPr>
              <a:xfrm>
                <a:off x="1789433" y="4644925"/>
                <a:ext cx="59213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Connector 75"/>
              <p:cNvCxnSpPr>
                <a:cxnSpLocks/>
              </p:cNvCxnSpPr>
              <p:nvPr/>
            </p:nvCxnSpPr>
            <p:spPr>
              <a:xfrm>
                <a:off x="1245441" y="4644925"/>
                <a:ext cx="3429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Straight Connector 76"/>
              <p:cNvCxnSpPr>
                <a:cxnSpLocks/>
              </p:cNvCxnSpPr>
              <p:nvPr/>
            </p:nvCxnSpPr>
            <p:spPr>
              <a:xfrm>
                <a:off x="2671729" y="4644925"/>
                <a:ext cx="59213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/>
              <p:cNvCxnSpPr>
                <a:cxnSpLocks/>
              </p:cNvCxnSpPr>
              <p:nvPr/>
            </p:nvCxnSpPr>
            <p:spPr>
              <a:xfrm>
                <a:off x="3590180" y="4644925"/>
                <a:ext cx="59213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9" name="TextBox 78"/>
              <p:cNvSpPr txBox="1"/>
              <p:nvPr/>
            </p:nvSpPr>
            <p:spPr>
              <a:xfrm>
                <a:off x="2274226" y="4873428"/>
                <a:ext cx="1810593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ncentration, </a:t>
                </a:r>
                <a:r>
                  <a:rPr lang="en-US" altLang="en-US" sz="1100" dirty="0">
                    <a:latin typeface="Symbol" pitchFamily="2" charset="2"/>
                    <a:cs typeface="Arial" panose="020B0604020202020204" pitchFamily="34" charset="0"/>
                  </a:rPr>
                  <a:t>m</a:t>
                </a:r>
                <a:r>
                  <a:rPr lang="en-US" alt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 rot="16200000">
                <a:off x="351526" y="3288937"/>
                <a:ext cx="1065162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Live cells, %</a:t>
                </a:r>
                <a:endParaRPr lang="en-US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81" name="TextBox 10"/>
              <p:cNvSpPr txBox="1">
                <a:spLocks noChangeArrowheads="1"/>
              </p:cNvSpPr>
              <p:nvPr/>
            </p:nvSpPr>
            <p:spPr bwMode="auto">
              <a:xfrm>
                <a:off x="4462673" y="2699186"/>
                <a:ext cx="64141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et-On</a:t>
                </a:r>
              </a:p>
            </p:txBody>
          </p:sp>
          <p:sp>
            <p:nvSpPr>
              <p:cNvPr id="82" name="Rectangle 81"/>
              <p:cNvSpPr/>
              <p:nvPr/>
            </p:nvSpPr>
            <p:spPr>
              <a:xfrm>
                <a:off x="4364735" y="2753047"/>
                <a:ext cx="120584" cy="107722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" name="TextBox 10"/>
              <p:cNvSpPr txBox="1">
                <a:spLocks noChangeArrowheads="1"/>
              </p:cNvSpPr>
              <p:nvPr/>
            </p:nvSpPr>
            <p:spPr bwMode="auto">
              <a:xfrm>
                <a:off x="4462673" y="2908756"/>
                <a:ext cx="64141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et-Off</a:t>
                </a:r>
              </a:p>
            </p:txBody>
          </p:sp>
          <p:sp>
            <p:nvSpPr>
              <p:cNvPr id="85" name="Rectangle 84"/>
              <p:cNvSpPr/>
              <p:nvPr/>
            </p:nvSpPr>
            <p:spPr>
              <a:xfrm>
                <a:off x="4364735" y="2971800"/>
                <a:ext cx="120584" cy="107722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E19CA611-70C0-EA56-FFAE-09FD2AAFA9E1}"/>
              </a:ext>
            </a:extLst>
          </p:cNvPr>
          <p:cNvGrpSpPr/>
          <p:nvPr/>
        </p:nvGrpSpPr>
        <p:grpSpPr>
          <a:xfrm>
            <a:off x="1335069" y="4677941"/>
            <a:ext cx="4055641" cy="2197054"/>
            <a:chOff x="535847" y="3374610"/>
            <a:chExt cx="2730280" cy="1327675"/>
          </a:xfrm>
        </p:grpSpPr>
        <p:sp>
          <p:nvSpPr>
            <p:cNvPr id="126" name="TextBox 125"/>
            <p:cNvSpPr txBox="1"/>
            <p:nvPr/>
          </p:nvSpPr>
          <p:spPr>
            <a:xfrm>
              <a:off x="777336" y="3374610"/>
              <a:ext cx="317311" cy="1487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1FEE3F17-57A4-C2D1-FB13-7AA02024D1D4}"/>
                </a:ext>
              </a:extLst>
            </p:cNvPr>
            <p:cNvGrpSpPr/>
            <p:nvPr/>
          </p:nvGrpSpPr>
          <p:grpSpPr>
            <a:xfrm>
              <a:off x="535847" y="3421712"/>
              <a:ext cx="2730280" cy="1280573"/>
              <a:chOff x="581864" y="6498699"/>
              <a:chExt cx="2730280" cy="1280573"/>
            </a:xfrm>
          </p:grpSpPr>
          <p:pic>
            <p:nvPicPr>
              <p:cNvPr id="29" name="Picture 67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12966" y="7420310"/>
                <a:ext cx="587375" cy="342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D43BDF57-D976-E3A2-6F59-CA52D97AB6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-50000"/>
                        </a14:imgEffect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271905" y="6795383"/>
                <a:ext cx="1596310" cy="98388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2" name="Rectangle 57">
                <a:extLst>
                  <a:ext uri="{FF2B5EF4-FFF2-40B4-BE49-F238E27FC236}">
                    <a16:creationId xmlns:a16="http://schemas.microsoft.com/office/drawing/2014/main" id="{14AD02BA-8C3A-02F9-5C99-A1CFFA0264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71333">
                <a:off x="1947548" y="6533124"/>
                <a:ext cx="600516" cy="1084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C458-8 1mM</a:t>
                </a:r>
                <a:endParaRPr kumimoji="0" lang="en-US" altLang="en-US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3" name="TextBox 7">
                <a:extLst>
                  <a:ext uri="{FF2B5EF4-FFF2-40B4-BE49-F238E27FC236}">
                    <a16:creationId xmlns:a16="http://schemas.microsoft.com/office/drawing/2014/main" id="{9CAB5CFD-C53D-7311-4A2F-1BD04BD5F07E}"/>
                  </a:ext>
                </a:extLst>
              </p:cNvPr>
              <p:cNvSpPr txBox="1"/>
              <p:nvPr/>
            </p:nvSpPr>
            <p:spPr>
              <a:xfrm rot="21519140">
                <a:off x="1365597" y="6616599"/>
                <a:ext cx="361083" cy="1735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kern="1200" dirty="0">
                    <a:effectLst/>
                    <a:latin typeface="Arial" panose="020B0604020202020204" pitchFamily="34" charset="0"/>
                    <a:ea typeface="Times New Roman"/>
                    <a:cs typeface="Arial" panose="020B0604020202020204" pitchFamily="34" charset="0"/>
                  </a:rPr>
                  <a:t>Input</a:t>
                </a:r>
                <a:endParaRPr lang="en-US" sz="1000" dirty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8">
                <a:extLst>
                  <a:ext uri="{FF2B5EF4-FFF2-40B4-BE49-F238E27FC236}">
                    <a16:creationId xmlns:a16="http://schemas.microsoft.com/office/drawing/2014/main" id="{19C74C45-AC57-D60D-D358-E7B372830BC1}"/>
                  </a:ext>
                </a:extLst>
              </p:cNvPr>
              <p:cNvSpPr txBox="1"/>
              <p:nvPr/>
            </p:nvSpPr>
            <p:spPr>
              <a:xfrm>
                <a:off x="1745528" y="6632339"/>
                <a:ext cx="299846" cy="1735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kern="1200" dirty="0">
                    <a:effectLst/>
                    <a:latin typeface="Arial" panose="020B0604020202020204" pitchFamily="34" charset="0"/>
                    <a:ea typeface="Times New Roman"/>
                    <a:cs typeface="Arial" panose="020B0604020202020204" pitchFamily="34" charset="0"/>
                  </a:rPr>
                  <a:t>IC</a:t>
                </a:r>
                <a:endParaRPr lang="en-US" sz="1000" dirty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endParaRPr>
              </a:p>
            </p:txBody>
          </p:sp>
          <p:sp>
            <p:nvSpPr>
              <p:cNvPr id="25" name="Rectangle 57">
                <a:extLst>
                  <a:ext uri="{FF2B5EF4-FFF2-40B4-BE49-F238E27FC236}">
                    <a16:creationId xmlns:a16="http://schemas.microsoft.com/office/drawing/2014/main" id="{B31AE998-FB5F-B7A4-6990-5CFD32ED01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71333">
                <a:off x="2120183" y="6498699"/>
                <a:ext cx="709927" cy="1084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C458-8 0.2 mM</a:t>
                </a:r>
                <a:endParaRPr kumimoji="0" lang="en-US" altLang="en-US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6" name="Rectangle 57">
                <a:extLst>
                  <a:ext uri="{FF2B5EF4-FFF2-40B4-BE49-F238E27FC236}">
                    <a16:creationId xmlns:a16="http://schemas.microsoft.com/office/drawing/2014/main" id="{30BE56DF-0C2E-9B3A-CCB7-8CD4482519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71333">
                <a:off x="2402228" y="6524517"/>
                <a:ext cx="627869" cy="1084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C458-2 1 mM</a:t>
                </a:r>
                <a:endParaRPr kumimoji="0" lang="en-US" altLang="en-US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7" name="Rectangle 57">
                <a:extLst>
                  <a:ext uri="{FF2B5EF4-FFF2-40B4-BE49-F238E27FC236}">
                    <a16:creationId xmlns:a16="http://schemas.microsoft.com/office/drawing/2014/main" id="{7D4C4846-540E-076E-9CDE-7A44DF30C8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71333">
                <a:off x="2602217" y="6498699"/>
                <a:ext cx="709927" cy="1084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C458-2 0.2 mM</a:t>
                </a:r>
                <a:endParaRPr kumimoji="0" lang="en-US" altLang="en-US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32861A03-40B3-7D13-83DD-F84883B35AF4}"/>
                  </a:ext>
                </a:extLst>
              </p:cNvPr>
              <p:cNvSpPr txBox="1"/>
              <p:nvPr/>
            </p:nvSpPr>
            <p:spPr>
              <a:xfrm>
                <a:off x="581864" y="7502124"/>
                <a:ext cx="604232" cy="1735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kern="1200" dirty="0">
                    <a:effectLst/>
                    <a:latin typeface="Arial" panose="020B0604020202020204" pitchFamily="34" charset="0"/>
                    <a:ea typeface="Times New Roman"/>
                    <a:cs typeface="Arial" panose="020B0604020202020204" pitchFamily="34" charset="0"/>
                  </a:rPr>
                  <a:t>NDUFA9</a:t>
                </a:r>
                <a:endParaRPr lang="en-US" sz="1000" dirty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endParaRPr>
              </a:p>
            </p:txBody>
          </p:sp>
          <p:cxnSp>
            <p:nvCxnSpPr>
              <p:cNvPr id="86" name="Straight Arrow Connector 85">
                <a:extLst>
                  <a:ext uri="{FF2B5EF4-FFF2-40B4-BE49-F238E27FC236}">
                    <a16:creationId xmlns:a16="http://schemas.microsoft.com/office/drawing/2014/main" id="{5C3BCE20-F01C-1A69-4F1E-C1C49932A9F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79236" y="7588254"/>
                <a:ext cx="179928" cy="136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" name="Straight Arrow Connector 3">
                <a:extLst>
                  <a:ext uri="{FF2B5EF4-FFF2-40B4-BE49-F238E27FC236}">
                    <a16:creationId xmlns:a16="http://schemas.microsoft.com/office/drawing/2014/main" id="{62199960-FCC2-C853-2422-0C41A490FCA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79236" y="7299533"/>
                <a:ext cx="179928" cy="136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B5ABC30B-DE34-1456-A21F-E797E9215291}"/>
                  </a:ext>
                </a:extLst>
              </p:cNvPr>
              <p:cNvSpPr txBox="1"/>
              <p:nvPr/>
            </p:nvSpPr>
            <p:spPr>
              <a:xfrm>
                <a:off x="767686" y="7212738"/>
                <a:ext cx="416525" cy="1735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kern="1200" dirty="0">
                    <a:effectLst/>
                    <a:latin typeface="Arial" panose="020B0604020202020204" pitchFamily="34" charset="0"/>
                    <a:ea typeface="Times New Roman"/>
                    <a:cs typeface="Arial" panose="020B0604020202020204" pitchFamily="34" charset="0"/>
                  </a:rPr>
                  <a:t>ND5</a:t>
                </a:r>
                <a:endParaRPr lang="en-US" sz="1000" dirty="0">
                  <a:effectLst/>
                  <a:latin typeface="Arial" panose="020B0604020202020204" pitchFamily="34" charset="0"/>
                  <a:ea typeface="Times New Roman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7BB1FBA2-A624-E191-7C00-2E03BE87F22F}"/>
              </a:ext>
            </a:extLst>
          </p:cNvPr>
          <p:cNvSpPr txBox="1"/>
          <p:nvPr/>
        </p:nvSpPr>
        <p:spPr>
          <a:xfrm>
            <a:off x="122027" y="7440083"/>
            <a:ext cx="6607367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/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2. C458 analogs protect against A</a:t>
            </a:r>
            <a:r>
              <a:rPr lang="en-US" sz="1100" b="1" dirty="0">
                <a:solidFill>
                  <a:srgbClr val="000000"/>
                </a:solidFill>
                <a:effectLst/>
                <a:latin typeface="Symbol" pitchFamily="2" charset="2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oxicity and bind </a:t>
            </a:r>
            <a:r>
              <a:rPr lang="en-US" sz="11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tCI</a:t>
            </a: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fficacy of C458-2 and C458-8 against A</a:t>
            </a:r>
            <a:r>
              <a:rPr lang="en-US" sz="1100" dirty="0">
                <a:solidFill>
                  <a:srgbClr val="000000"/>
                </a:solidFill>
                <a:effectLst/>
                <a:latin typeface="Symbol" pitchFamily="2" charset="2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oxicity in MC65 cells. Experiments were performed in triplicates in three independent cultures. </a:t>
            </a: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en-US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tCI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as pulled down from 1 mg of mitochondrial lysate using C458-8 and C458-2 immobilized on agarose beads. 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oth C458-2 and C458-8 were immobilized on NHS-activated agarose at two concentrations: 1 mM and 0.2 </a:t>
            </a:r>
            <a:r>
              <a:rPr lang="en-US" sz="11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M.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put is 50 </a:t>
            </a:r>
            <a:r>
              <a:rPr lang="en-US" sz="1100" dirty="0">
                <a:solidFill>
                  <a:srgbClr val="000000"/>
                </a:solidFill>
                <a:effectLst/>
                <a:latin typeface="Symbol" pitchFamily="2" charset="2"/>
                <a:ea typeface="Times New Roman" panose="02020603050405020304" pitchFamily="18" charset="0"/>
                <a:cs typeface="Arial" panose="020B0604020202020204" pitchFamily="34" charset="0"/>
              </a:rPr>
              <a:t>m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 of mitochondrial lysate; IC represents immunocapture of </a:t>
            </a:r>
            <a:r>
              <a:rPr lang="en-US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tCI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rom 1 mg of mitochondrial lysate with </a:t>
            </a:r>
            <a:r>
              <a:rPr lang="en-US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tCI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tibodies (Abcam). </a:t>
            </a:r>
            <a:r>
              <a:rPr lang="en-US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tCI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as detected by immunoblotting for NDUFA9 and ND5 subunits.</a:t>
            </a:r>
            <a:endParaRPr lang="en-US" sz="1100" dirty="0">
              <a:effectLst/>
              <a:latin typeface="Aptos" panose="020B00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5816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50713</TotalTime>
  <Words>157</Words>
  <Application>Microsoft Office PowerPoint</Application>
  <PresentationFormat>On-screen Show (4:3)</PresentationFormat>
  <Paragraphs>3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ptos</vt:lpstr>
      <vt:lpstr>Arial</vt:lpstr>
      <vt:lpstr>Calibri</vt:lpstr>
      <vt:lpstr>Symbol</vt:lpstr>
      <vt:lpstr>Times New Roman</vt:lpstr>
      <vt:lpstr>Office Theme</vt:lpstr>
      <vt:lpstr>Prism 10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A Trushin</dc:creator>
  <cp:lastModifiedBy>Trushin, Sergey A., Ph.D.</cp:lastModifiedBy>
  <cp:revision>604</cp:revision>
  <cp:lastPrinted>2022-11-09T15:46:24Z</cp:lastPrinted>
  <dcterms:created xsi:type="dcterms:W3CDTF">2020-01-31T17:27:01Z</dcterms:created>
  <dcterms:modified xsi:type="dcterms:W3CDTF">2025-02-12T20:26:27Z</dcterms:modified>
</cp:coreProperties>
</file>